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4"/>
  </p:sldMasterIdLst>
  <p:notesMasterIdLst>
    <p:notesMasterId r:id="rId6"/>
  </p:notesMasterIdLst>
  <p:sldIdLst>
    <p:sldId id="311" r:id="rId5"/>
  </p:sldIdLst>
  <p:sldSz cx="6858000" cy="9906000" type="A4"/>
  <p:notesSz cx="7315200" cy="96012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33CC"/>
    <a:srgbClr val="CC9900"/>
    <a:srgbClr val="FFCC00"/>
    <a:srgbClr val="FFFFFF"/>
    <a:srgbClr val="E8B7B7"/>
    <a:srgbClr val="A8CDD7"/>
    <a:srgbClr val="FF505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20"/>
    <p:restoredTop sz="95161" autoAdjust="0"/>
  </p:normalViewPr>
  <p:slideViewPr>
    <p:cSldViewPr snapToGrid="0">
      <p:cViewPr varScale="1">
        <p:scale>
          <a:sx n="71" d="100"/>
          <a:sy n="71" d="100"/>
        </p:scale>
        <p:origin x="66" y="5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customXml" Target="../customXml/item3.xml"/><Relationship Id="rId7" Type="http://schemas.openxmlformats.org/officeDocument/2006/relationships/presProps" Target="presProps.xml"/><Relationship Id="rId2" Type="http://schemas.openxmlformats.org/officeDocument/2006/relationships/customXml" Target="../customXml/item2.xml"/><Relationship Id="rId1" Type="http://schemas.openxmlformats.org/officeDocument/2006/relationships/customXml" Target="../customXml/item1.xml"/><Relationship Id="rId6" Type="http://schemas.openxmlformats.org/officeDocument/2006/relationships/notesMaster" Target="notesMasters/notesMaster1.xml"/><Relationship Id="rId11" Type="http://schemas.microsoft.com/office/2016/11/relationships/changesInfo" Target="changesInfos/changesInfo1.xml"/><Relationship Id="rId5" Type="http://schemas.openxmlformats.org/officeDocument/2006/relationships/slide" Target="slides/slide1.xml"/><Relationship Id="rId10" Type="http://schemas.openxmlformats.org/officeDocument/2006/relationships/tableStyles" Target="tableStyles.xml"/><Relationship Id="rId4" Type="http://schemas.openxmlformats.org/officeDocument/2006/relationships/slideMaster" Target="slideMasters/slideMaster1.xml"/><Relationship Id="rId9" Type="http://schemas.openxmlformats.org/officeDocument/2006/relationships/theme" Target="theme/theme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ara Weis" userId="6a51f4e6-0e93-4a18-834c-a49e1ed77407" providerId="ADAL" clId="{6959E033-7E6A-4EA0-AB19-75F676599088}"/>
    <pc:docChg chg="undo custSel addSld modSld">
      <pc:chgData name="Sara Weis" userId="6a51f4e6-0e93-4a18-834c-a49e1ed77407" providerId="ADAL" clId="{6959E033-7E6A-4EA0-AB19-75F676599088}" dt="2025-01-02T17:18:45.578" v="422" actId="1076"/>
      <pc:docMkLst>
        <pc:docMk/>
      </pc:docMkLst>
      <pc:sldChg chg="addSp delSp modSp">
        <pc:chgData name="Sara Weis" userId="6a51f4e6-0e93-4a18-834c-a49e1ed77407" providerId="ADAL" clId="{6959E033-7E6A-4EA0-AB19-75F676599088}" dt="2025-01-02T17:15:24.765" v="382" actId="20577"/>
        <pc:sldMkLst>
          <pc:docMk/>
          <pc:sldMk cId="2106248321" sldId="298"/>
        </pc:sldMkLst>
        <pc:spChg chg="add mod">
          <ac:chgData name="Sara Weis" userId="6a51f4e6-0e93-4a18-834c-a49e1ed77407" providerId="ADAL" clId="{6959E033-7E6A-4EA0-AB19-75F676599088}" dt="2025-01-02T17:15:24.765" v="382" actId="20577"/>
          <ac:spMkLst>
            <pc:docMk/>
            <pc:sldMk cId="2106248321" sldId="298"/>
            <ac:spMk id="3" creationId="{F85F01AF-E2FC-4A20-BC96-820C3267DBD5}"/>
          </ac:spMkLst>
        </pc:spChg>
        <pc:spChg chg="mod">
          <ac:chgData name="Sara Weis" userId="6a51f4e6-0e93-4a18-834c-a49e1ed77407" providerId="ADAL" clId="{6959E033-7E6A-4EA0-AB19-75F676599088}" dt="2025-01-02T16:56:55.861" v="67" actId="122"/>
          <ac:spMkLst>
            <pc:docMk/>
            <pc:sldMk cId="2106248321" sldId="298"/>
            <ac:spMk id="9" creationId="{75936999-04B7-4CA0-96C9-CD97C06BD1F1}"/>
          </ac:spMkLst>
        </pc:spChg>
        <pc:spChg chg="mod">
          <ac:chgData name="Sara Weis" userId="6a51f4e6-0e93-4a18-834c-a49e1ed77407" providerId="ADAL" clId="{6959E033-7E6A-4EA0-AB19-75F676599088}" dt="2025-01-02T16:56:55.861" v="67" actId="122"/>
          <ac:spMkLst>
            <pc:docMk/>
            <pc:sldMk cId="2106248321" sldId="298"/>
            <ac:spMk id="10" creationId="{98561D18-56B5-4A22-B657-19C0C43B029A}"/>
          </ac:spMkLst>
        </pc:spChg>
        <pc:spChg chg="mod">
          <ac:chgData name="Sara Weis" userId="6a51f4e6-0e93-4a18-834c-a49e1ed77407" providerId="ADAL" clId="{6959E033-7E6A-4EA0-AB19-75F676599088}" dt="2025-01-02T16:56:55.861" v="67" actId="122"/>
          <ac:spMkLst>
            <pc:docMk/>
            <pc:sldMk cId="2106248321" sldId="298"/>
            <ac:spMk id="11" creationId="{06F6387F-5DC2-44EE-B710-A3F4811AD05E}"/>
          </ac:spMkLst>
        </pc:spChg>
        <pc:spChg chg="mod">
          <ac:chgData name="Sara Weis" userId="6a51f4e6-0e93-4a18-834c-a49e1ed77407" providerId="ADAL" clId="{6959E033-7E6A-4EA0-AB19-75F676599088}" dt="2025-01-02T16:56:55.861" v="67" actId="122"/>
          <ac:spMkLst>
            <pc:docMk/>
            <pc:sldMk cId="2106248321" sldId="298"/>
            <ac:spMk id="12" creationId="{B599E299-20AD-4B90-863E-C9F21A3FC407}"/>
          </ac:spMkLst>
        </pc:spChg>
        <pc:spChg chg="mod">
          <ac:chgData name="Sara Weis" userId="6a51f4e6-0e93-4a18-834c-a49e1ed77407" providerId="ADAL" clId="{6959E033-7E6A-4EA0-AB19-75F676599088}" dt="2025-01-02T16:56:55.861" v="67" actId="122"/>
          <ac:spMkLst>
            <pc:docMk/>
            <pc:sldMk cId="2106248321" sldId="298"/>
            <ac:spMk id="19" creationId="{236DD729-0233-4845-B1E1-FF2549A9C872}"/>
          </ac:spMkLst>
        </pc:spChg>
        <pc:spChg chg="mod">
          <ac:chgData name="Sara Weis" userId="6a51f4e6-0e93-4a18-834c-a49e1ed77407" providerId="ADAL" clId="{6959E033-7E6A-4EA0-AB19-75F676599088}" dt="2025-01-02T16:56:55.861" v="67" actId="122"/>
          <ac:spMkLst>
            <pc:docMk/>
            <pc:sldMk cId="2106248321" sldId="298"/>
            <ac:spMk id="20" creationId="{87F2151C-91AE-444F-BA0A-F5DE6A8495AA}"/>
          </ac:spMkLst>
        </pc:spChg>
        <pc:spChg chg="mod">
          <ac:chgData name="Sara Weis" userId="6a51f4e6-0e93-4a18-834c-a49e1ed77407" providerId="ADAL" clId="{6959E033-7E6A-4EA0-AB19-75F676599088}" dt="2025-01-02T17:08:03.483" v="375" actId="1076"/>
          <ac:spMkLst>
            <pc:docMk/>
            <pc:sldMk cId="2106248321" sldId="298"/>
            <ac:spMk id="23" creationId="{9837469B-6902-495A-86E3-722D7C6A57DC}"/>
          </ac:spMkLst>
        </pc:spChg>
        <pc:spChg chg="del">
          <ac:chgData name="Sara Weis" userId="6a51f4e6-0e93-4a18-834c-a49e1ed77407" providerId="ADAL" clId="{6959E033-7E6A-4EA0-AB19-75F676599088}" dt="2025-01-02T17:05:57.477" v="359" actId="478"/>
          <ac:spMkLst>
            <pc:docMk/>
            <pc:sldMk cId="2106248321" sldId="298"/>
            <ac:spMk id="45" creationId="{F3A9156C-C54C-4614-ABB9-5AF095F0F775}"/>
          </ac:spMkLst>
        </pc:spChg>
        <pc:spChg chg="mod">
          <ac:chgData name="Sara Weis" userId="6a51f4e6-0e93-4a18-834c-a49e1ed77407" providerId="ADAL" clId="{6959E033-7E6A-4EA0-AB19-75F676599088}" dt="2025-01-02T16:57:01.182" v="68" actId="1076"/>
          <ac:spMkLst>
            <pc:docMk/>
            <pc:sldMk cId="2106248321" sldId="298"/>
            <ac:spMk id="56" creationId="{1CE285CC-DC0D-4825-9EDF-E3D5D8427719}"/>
          </ac:spMkLst>
        </pc:spChg>
        <pc:spChg chg="mod">
          <ac:chgData name="Sara Weis" userId="6a51f4e6-0e93-4a18-834c-a49e1ed77407" providerId="ADAL" clId="{6959E033-7E6A-4EA0-AB19-75F676599088}" dt="2025-01-02T17:08:03.483" v="375" actId="1076"/>
          <ac:spMkLst>
            <pc:docMk/>
            <pc:sldMk cId="2106248321" sldId="298"/>
            <ac:spMk id="70" creationId="{7A30D47F-4FE9-4840-9977-6022DD4A371A}"/>
          </ac:spMkLst>
        </pc:spChg>
        <pc:spChg chg="mod">
          <ac:chgData name="Sara Weis" userId="6a51f4e6-0e93-4a18-834c-a49e1ed77407" providerId="ADAL" clId="{6959E033-7E6A-4EA0-AB19-75F676599088}" dt="2025-01-02T16:56:55.861" v="67" actId="122"/>
          <ac:spMkLst>
            <pc:docMk/>
            <pc:sldMk cId="2106248321" sldId="298"/>
            <ac:spMk id="76" creationId="{3F6D0F30-184D-40C5-AF9D-82030B65FD09}"/>
          </ac:spMkLst>
        </pc:spChg>
        <pc:spChg chg="mod">
          <ac:chgData name="Sara Weis" userId="6a51f4e6-0e93-4a18-834c-a49e1ed77407" providerId="ADAL" clId="{6959E033-7E6A-4EA0-AB19-75F676599088}" dt="2025-01-02T16:56:55.861" v="67" actId="122"/>
          <ac:spMkLst>
            <pc:docMk/>
            <pc:sldMk cId="2106248321" sldId="298"/>
            <ac:spMk id="77" creationId="{8CB2C145-4003-477F-81BA-EEA2846A0D4F}"/>
          </ac:spMkLst>
        </pc:spChg>
        <pc:spChg chg="mod">
          <ac:chgData name="Sara Weis" userId="6a51f4e6-0e93-4a18-834c-a49e1ed77407" providerId="ADAL" clId="{6959E033-7E6A-4EA0-AB19-75F676599088}" dt="2025-01-02T16:56:55.861" v="67" actId="122"/>
          <ac:spMkLst>
            <pc:docMk/>
            <pc:sldMk cId="2106248321" sldId="298"/>
            <ac:spMk id="78" creationId="{5B67D640-44A5-4C40-8143-D52616D97BD9}"/>
          </ac:spMkLst>
        </pc:spChg>
        <pc:spChg chg="mod">
          <ac:chgData name="Sara Weis" userId="6a51f4e6-0e93-4a18-834c-a49e1ed77407" providerId="ADAL" clId="{6959E033-7E6A-4EA0-AB19-75F676599088}" dt="2025-01-02T16:56:55.861" v="67" actId="122"/>
          <ac:spMkLst>
            <pc:docMk/>
            <pc:sldMk cId="2106248321" sldId="298"/>
            <ac:spMk id="84" creationId="{B5744F81-4DF0-4530-87BD-B543F756DD8F}"/>
          </ac:spMkLst>
        </pc:spChg>
        <pc:spChg chg="mod">
          <ac:chgData name="Sara Weis" userId="6a51f4e6-0e93-4a18-834c-a49e1ed77407" providerId="ADAL" clId="{6959E033-7E6A-4EA0-AB19-75F676599088}" dt="2025-01-02T16:56:55.861" v="67" actId="122"/>
          <ac:spMkLst>
            <pc:docMk/>
            <pc:sldMk cId="2106248321" sldId="298"/>
            <ac:spMk id="85" creationId="{D04BE4A0-467D-4070-B64B-9F2C118EF847}"/>
          </ac:spMkLst>
        </pc:spChg>
        <pc:spChg chg="mod">
          <ac:chgData name="Sara Weis" userId="6a51f4e6-0e93-4a18-834c-a49e1ed77407" providerId="ADAL" clId="{6959E033-7E6A-4EA0-AB19-75F676599088}" dt="2025-01-02T16:56:55.861" v="67" actId="122"/>
          <ac:spMkLst>
            <pc:docMk/>
            <pc:sldMk cId="2106248321" sldId="298"/>
            <ac:spMk id="86" creationId="{98515101-AB5F-4E78-A682-FFAEA0B99110}"/>
          </ac:spMkLst>
        </pc:spChg>
        <pc:spChg chg="mod">
          <ac:chgData name="Sara Weis" userId="6a51f4e6-0e93-4a18-834c-a49e1ed77407" providerId="ADAL" clId="{6959E033-7E6A-4EA0-AB19-75F676599088}" dt="2025-01-02T16:56:55.861" v="67" actId="122"/>
          <ac:spMkLst>
            <pc:docMk/>
            <pc:sldMk cId="2106248321" sldId="298"/>
            <ac:spMk id="88" creationId="{5C118BE6-EAB6-49A0-8589-3C1535D4CA55}"/>
          </ac:spMkLst>
        </pc:spChg>
        <pc:spChg chg="mod">
          <ac:chgData name="Sara Weis" userId="6a51f4e6-0e93-4a18-834c-a49e1ed77407" providerId="ADAL" clId="{6959E033-7E6A-4EA0-AB19-75F676599088}" dt="2025-01-02T16:57:10.910" v="87" actId="1035"/>
          <ac:spMkLst>
            <pc:docMk/>
            <pc:sldMk cId="2106248321" sldId="298"/>
            <ac:spMk id="94" creationId="{2650BDE5-AD2F-42F9-A372-1968EC006B7E}"/>
          </ac:spMkLst>
        </pc:spChg>
        <pc:grpChg chg="add mod">
          <ac:chgData name="Sara Weis" userId="6a51f4e6-0e93-4a18-834c-a49e1ed77407" providerId="ADAL" clId="{6959E033-7E6A-4EA0-AB19-75F676599088}" dt="2025-01-02T17:08:09.193" v="377" actId="14100"/>
          <ac:grpSpMkLst>
            <pc:docMk/>
            <pc:sldMk cId="2106248321" sldId="298"/>
            <ac:grpSpMk id="2" creationId="{960064E3-9BEA-4925-8610-BCA826CE0C41}"/>
          </ac:grpSpMkLst>
        </pc:grpChg>
        <pc:grpChg chg="mod">
          <ac:chgData name="Sara Weis" userId="6a51f4e6-0e93-4a18-834c-a49e1ed77407" providerId="ADAL" clId="{6959E033-7E6A-4EA0-AB19-75F676599088}" dt="2025-01-02T16:56:35.670" v="63" actId="164"/>
          <ac:grpSpMkLst>
            <pc:docMk/>
            <pc:sldMk cId="2106248321" sldId="298"/>
            <ac:grpSpMk id="18" creationId="{6C3C0227-C401-42B7-83D7-5BCA28C7679E}"/>
          </ac:grpSpMkLst>
        </pc:grpChg>
        <pc:grpChg chg="mod">
          <ac:chgData name="Sara Weis" userId="6a51f4e6-0e93-4a18-834c-a49e1ed77407" providerId="ADAL" clId="{6959E033-7E6A-4EA0-AB19-75F676599088}" dt="2025-01-02T16:56:35.670" v="63" actId="164"/>
          <ac:grpSpMkLst>
            <pc:docMk/>
            <pc:sldMk cId="2106248321" sldId="298"/>
            <ac:grpSpMk id="24" creationId="{D5F64F85-735E-4924-B238-3BB390ADA6D2}"/>
          </ac:grpSpMkLst>
        </pc:grpChg>
        <pc:cxnChg chg="mod">
          <ac:chgData name="Sara Weis" userId="6a51f4e6-0e93-4a18-834c-a49e1ed77407" providerId="ADAL" clId="{6959E033-7E6A-4EA0-AB19-75F676599088}" dt="2025-01-02T16:56:35.670" v="63" actId="164"/>
          <ac:cxnSpMkLst>
            <pc:docMk/>
            <pc:sldMk cId="2106248321" sldId="298"/>
            <ac:cxnSpMk id="55" creationId="{444086A9-B7E4-41B3-B776-3280FA8A5349}"/>
          </ac:cxnSpMkLst>
        </pc:cxnChg>
        <pc:cxnChg chg="mod">
          <ac:chgData name="Sara Weis" userId="6a51f4e6-0e93-4a18-834c-a49e1ed77407" providerId="ADAL" clId="{6959E033-7E6A-4EA0-AB19-75F676599088}" dt="2025-01-02T16:57:10.910" v="87" actId="1035"/>
          <ac:cxnSpMkLst>
            <pc:docMk/>
            <pc:sldMk cId="2106248321" sldId="298"/>
            <ac:cxnSpMk id="93" creationId="{DBB2319C-3D95-4D00-AFE1-D23979B8E566}"/>
          </ac:cxnSpMkLst>
        </pc:cxnChg>
      </pc:sldChg>
      <pc:sldChg chg="addSp delSp modSp">
        <pc:chgData name="Sara Weis" userId="6a51f4e6-0e93-4a18-834c-a49e1ed77407" providerId="ADAL" clId="{6959E033-7E6A-4EA0-AB19-75F676599088}" dt="2025-01-02T17:18:45.578" v="422" actId="1076"/>
        <pc:sldMkLst>
          <pc:docMk/>
          <pc:sldMk cId="1407140874" sldId="309"/>
        </pc:sldMkLst>
        <pc:spChg chg="add mod">
          <ac:chgData name="Sara Weis" userId="6a51f4e6-0e93-4a18-834c-a49e1ed77407" providerId="ADAL" clId="{6959E033-7E6A-4EA0-AB19-75F676599088}" dt="2025-01-02T17:16:14.495" v="386" actId="403"/>
          <ac:spMkLst>
            <pc:docMk/>
            <pc:sldMk cId="1407140874" sldId="309"/>
            <ac:spMk id="3" creationId="{442AB1F2-5941-4F44-AC8D-E4A87AD7535C}"/>
          </ac:spMkLst>
        </pc:spChg>
        <pc:spChg chg="del">
          <ac:chgData name="Sara Weis" userId="6a51f4e6-0e93-4a18-834c-a49e1ed77407" providerId="ADAL" clId="{6959E033-7E6A-4EA0-AB19-75F676599088}" dt="2025-01-02T16:58:07.845" v="111" actId="478"/>
          <ac:spMkLst>
            <pc:docMk/>
            <pc:sldMk cId="1407140874" sldId="309"/>
            <ac:spMk id="5" creationId="{B847A6B5-FE3F-456F-A592-96E2D8DDCCD8}"/>
          </ac:spMkLst>
        </pc:spChg>
        <pc:spChg chg="mod topLvl">
          <ac:chgData name="Sara Weis" userId="6a51f4e6-0e93-4a18-834c-a49e1ed77407" providerId="ADAL" clId="{6959E033-7E6A-4EA0-AB19-75F676599088}" dt="2025-01-02T17:00:26.168" v="180" actId="164"/>
          <ac:spMkLst>
            <pc:docMk/>
            <pc:sldMk cId="1407140874" sldId="309"/>
            <ac:spMk id="7" creationId="{65344804-014D-4F7F-89BE-8FDBDC89E59A}"/>
          </ac:spMkLst>
        </pc:spChg>
        <pc:spChg chg="mod topLvl">
          <ac:chgData name="Sara Weis" userId="6a51f4e6-0e93-4a18-834c-a49e1ed77407" providerId="ADAL" clId="{6959E033-7E6A-4EA0-AB19-75F676599088}" dt="2025-01-02T17:00:26.168" v="180" actId="164"/>
          <ac:spMkLst>
            <pc:docMk/>
            <pc:sldMk cId="1407140874" sldId="309"/>
            <ac:spMk id="8" creationId="{08887007-58A9-4043-A9A2-D0CC96D1F9D6}"/>
          </ac:spMkLst>
        </pc:spChg>
        <pc:spChg chg="mod topLvl">
          <ac:chgData name="Sara Weis" userId="6a51f4e6-0e93-4a18-834c-a49e1ed77407" providerId="ADAL" clId="{6959E033-7E6A-4EA0-AB19-75F676599088}" dt="2025-01-02T17:18:41.401" v="421" actId="1076"/>
          <ac:spMkLst>
            <pc:docMk/>
            <pc:sldMk cId="1407140874" sldId="309"/>
            <ac:spMk id="20" creationId="{6881229C-7153-4EB2-8DAA-13FD4A567142}"/>
          </ac:spMkLst>
        </pc:spChg>
        <pc:spChg chg="mod topLvl">
          <ac:chgData name="Sara Weis" userId="6a51f4e6-0e93-4a18-834c-a49e1ed77407" providerId="ADAL" clId="{6959E033-7E6A-4EA0-AB19-75F676599088}" dt="2025-01-02T17:00:26.168" v="180" actId="164"/>
          <ac:spMkLst>
            <pc:docMk/>
            <pc:sldMk cId="1407140874" sldId="309"/>
            <ac:spMk id="25" creationId="{1739EE7F-4B26-492C-9A21-D8B4D53A95D3}"/>
          </ac:spMkLst>
        </pc:spChg>
        <pc:spChg chg="mod topLvl">
          <ac:chgData name="Sara Weis" userId="6a51f4e6-0e93-4a18-834c-a49e1ed77407" providerId="ADAL" clId="{6959E033-7E6A-4EA0-AB19-75F676599088}" dt="2025-01-02T17:00:26.168" v="180" actId="164"/>
          <ac:spMkLst>
            <pc:docMk/>
            <pc:sldMk cId="1407140874" sldId="309"/>
            <ac:spMk id="26" creationId="{9F8B62C0-0701-4452-9ECE-E70CF3460A27}"/>
          </ac:spMkLst>
        </pc:spChg>
        <pc:spChg chg="mod topLvl">
          <ac:chgData name="Sara Weis" userId="6a51f4e6-0e93-4a18-834c-a49e1ed77407" providerId="ADAL" clId="{6959E033-7E6A-4EA0-AB19-75F676599088}" dt="2025-01-02T17:18:41.401" v="421" actId="1076"/>
          <ac:spMkLst>
            <pc:docMk/>
            <pc:sldMk cId="1407140874" sldId="309"/>
            <ac:spMk id="27" creationId="{AFD89C10-828B-4348-9400-D3F10865C33A}"/>
          </ac:spMkLst>
        </pc:spChg>
        <pc:spChg chg="mod topLvl">
          <ac:chgData name="Sara Weis" userId="6a51f4e6-0e93-4a18-834c-a49e1ed77407" providerId="ADAL" clId="{6959E033-7E6A-4EA0-AB19-75F676599088}" dt="2025-01-02T17:18:41.401" v="421" actId="1076"/>
          <ac:spMkLst>
            <pc:docMk/>
            <pc:sldMk cId="1407140874" sldId="309"/>
            <ac:spMk id="29" creationId="{96BDDBF5-E0E9-4EDD-8442-02BF3C3A13F5}"/>
          </ac:spMkLst>
        </pc:spChg>
        <pc:spChg chg="mod topLvl">
          <ac:chgData name="Sara Weis" userId="6a51f4e6-0e93-4a18-834c-a49e1ed77407" providerId="ADAL" clId="{6959E033-7E6A-4EA0-AB19-75F676599088}" dt="2025-01-02T17:00:26.168" v="180" actId="164"/>
          <ac:spMkLst>
            <pc:docMk/>
            <pc:sldMk cId="1407140874" sldId="309"/>
            <ac:spMk id="31" creationId="{7D00C1B0-C791-429C-AD61-4475D35B2BB9}"/>
          </ac:spMkLst>
        </pc:spChg>
        <pc:spChg chg="mod topLvl">
          <ac:chgData name="Sara Weis" userId="6a51f4e6-0e93-4a18-834c-a49e1ed77407" providerId="ADAL" clId="{6959E033-7E6A-4EA0-AB19-75F676599088}" dt="2025-01-02T17:00:26.168" v="180" actId="164"/>
          <ac:spMkLst>
            <pc:docMk/>
            <pc:sldMk cId="1407140874" sldId="309"/>
            <ac:spMk id="32" creationId="{4B4C88B7-534D-4392-8B45-CD4DBD0E06DC}"/>
          </ac:spMkLst>
        </pc:spChg>
        <pc:spChg chg="add del mod">
          <ac:chgData name="Sara Weis" userId="6a51f4e6-0e93-4a18-834c-a49e1ed77407" providerId="ADAL" clId="{6959E033-7E6A-4EA0-AB19-75F676599088}" dt="2025-01-02T17:05:36.901" v="355" actId="478"/>
          <ac:spMkLst>
            <pc:docMk/>
            <pc:sldMk cId="1407140874" sldId="309"/>
            <ac:spMk id="36" creationId="{146899AB-8D1C-4F16-8820-601965BA1003}"/>
          </ac:spMkLst>
        </pc:spChg>
        <pc:spChg chg="mod topLvl">
          <ac:chgData name="Sara Weis" userId="6a51f4e6-0e93-4a18-834c-a49e1ed77407" providerId="ADAL" clId="{6959E033-7E6A-4EA0-AB19-75F676599088}" dt="2025-01-02T17:00:26.168" v="180" actId="164"/>
          <ac:spMkLst>
            <pc:docMk/>
            <pc:sldMk cId="1407140874" sldId="309"/>
            <ac:spMk id="62" creationId="{108CAF4E-2AB6-4B17-9E6F-F1E346041C65}"/>
          </ac:spMkLst>
        </pc:spChg>
        <pc:spChg chg="mod topLvl">
          <ac:chgData name="Sara Weis" userId="6a51f4e6-0e93-4a18-834c-a49e1ed77407" providerId="ADAL" clId="{6959E033-7E6A-4EA0-AB19-75F676599088}" dt="2025-01-02T17:00:26.168" v="180" actId="164"/>
          <ac:spMkLst>
            <pc:docMk/>
            <pc:sldMk cId="1407140874" sldId="309"/>
            <ac:spMk id="63" creationId="{511BFF64-48D6-483A-8213-539471607A7B}"/>
          </ac:spMkLst>
        </pc:spChg>
        <pc:spChg chg="mod topLvl">
          <ac:chgData name="Sara Weis" userId="6a51f4e6-0e93-4a18-834c-a49e1ed77407" providerId="ADAL" clId="{6959E033-7E6A-4EA0-AB19-75F676599088}" dt="2025-01-02T17:00:26.168" v="180" actId="164"/>
          <ac:spMkLst>
            <pc:docMk/>
            <pc:sldMk cId="1407140874" sldId="309"/>
            <ac:spMk id="66" creationId="{B972A8FF-4AEE-45F4-8801-82D1725996E7}"/>
          </ac:spMkLst>
        </pc:spChg>
        <pc:spChg chg="mod topLvl">
          <ac:chgData name="Sara Weis" userId="6a51f4e6-0e93-4a18-834c-a49e1ed77407" providerId="ADAL" clId="{6959E033-7E6A-4EA0-AB19-75F676599088}" dt="2025-01-02T17:00:26.168" v="180" actId="164"/>
          <ac:spMkLst>
            <pc:docMk/>
            <pc:sldMk cId="1407140874" sldId="309"/>
            <ac:spMk id="69" creationId="{7818342E-B8CF-47E2-93C2-646CD55FFAA5}"/>
          </ac:spMkLst>
        </pc:spChg>
        <pc:spChg chg="mod topLvl">
          <ac:chgData name="Sara Weis" userId="6a51f4e6-0e93-4a18-834c-a49e1ed77407" providerId="ADAL" clId="{6959E033-7E6A-4EA0-AB19-75F676599088}" dt="2025-01-02T17:00:26.168" v="180" actId="164"/>
          <ac:spMkLst>
            <pc:docMk/>
            <pc:sldMk cId="1407140874" sldId="309"/>
            <ac:spMk id="71" creationId="{BAD48846-1FF2-41CD-B750-B8CF8ED157F2}"/>
          </ac:spMkLst>
        </pc:spChg>
        <pc:spChg chg="mod topLvl">
          <ac:chgData name="Sara Weis" userId="6a51f4e6-0e93-4a18-834c-a49e1ed77407" providerId="ADAL" clId="{6959E033-7E6A-4EA0-AB19-75F676599088}" dt="2025-01-02T17:00:26.168" v="180" actId="164"/>
          <ac:spMkLst>
            <pc:docMk/>
            <pc:sldMk cId="1407140874" sldId="309"/>
            <ac:spMk id="72" creationId="{0B7EA0DE-D9AC-44F8-A250-58B0B4C4310A}"/>
          </ac:spMkLst>
        </pc:spChg>
        <pc:grpChg chg="add del mod">
          <ac:chgData name="Sara Weis" userId="6a51f4e6-0e93-4a18-834c-a49e1ed77407" providerId="ADAL" clId="{6959E033-7E6A-4EA0-AB19-75F676599088}" dt="2025-01-02T16:59:03.173" v="126" actId="165"/>
          <ac:grpSpMkLst>
            <pc:docMk/>
            <pc:sldMk cId="1407140874" sldId="309"/>
            <ac:grpSpMk id="2" creationId="{9BD144CA-C724-4B0F-B95A-C3F7FD4A5043}"/>
          </ac:grpSpMkLst>
        </pc:grpChg>
        <pc:grpChg chg="add mod">
          <ac:chgData name="Sara Weis" userId="6a51f4e6-0e93-4a18-834c-a49e1ed77407" providerId="ADAL" clId="{6959E033-7E6A-4EA0-AB19-75F676599088}" dt="2025-01-02T17:18:45.578" v="422" actId="1076"/>
          <ac:grpSpMkLst>
            <pc:docMk/>
            <pc:sldMk cId="1407140874" sldId="309"/>
            <ac:grpSpMk id="4" creationId="{EF7220AD-9458-4B13-9101-12BFA96A1810}"/>
          </ac:grpSpMkLst>
        </pc:grpChg>
        <pc:grpChg chg="mod topLvl">
          <ac:chgData name="Sara Weis" userId="6a51f4e6-0e93-4a18-834c-a49e1ed77407" providerId="ADAL" clId="{6959E033-7E6A-4EA0-AB19-75F676599088}" dt="2025-01-02T17:00:26.168" v="180" actId="164"/>
          <ac:grpSpMkLst>
            <pc:docMk/>
            <pc:sldMk cId="1407140874" sldId="309"/>
            <ac:grpSpMk id="35" creationId="{056DD648-E1CF-4B28-A93C-9EA63B3183AD}"/>
          </ac:grpSpMkLst>
        </pc:grpChg>
        <pc:grpChg chg="del mod topLvl">
          <ac:chgData name="Sara Weis" userId="6a51f4e6-0e93-4a18-834c-a49e1ed77407" providerId="ADAL" clId="{6959E033-7E6A-4EA0-AB19-75F676599088}" dt="2025-01-02T16:59:38.932" v="151" actId="165"/>
          <ac:grpSpMkLst>
            <pc:docMk/>
            <pc:sldMk cId="1407140874" sldId="309"/>
            <ac:grpSpMk id="77" creationId="{D67AE77C-DCA4-4EA9-BF3B-04475E2533A4}"/>
          </ac:grpSpMkLst>
        </pc:grpChg>
        <pc:picChg chg="mod topLvl">
          <ac:chgData name="Sara Weis" userId="6a51f4e6-0e93-4a18-834c-a49e1ed77407" providerId="ADAL" clId="{6959E033-7E6A-4EA0-AB19-75F676599088}" dt="2025-01-02T17:00:26.168" v="180" actId="164"/>
          <ac:picMkLst>
            <pc:docMk/>
            <pc:sldMk cId="1407140874" sldId="309"/>
            <ac:picMk id="19" creationId="{27EEF4B6-3B61-44D0-85D1-A7E062BA449C}"/>
          </ac:picMkLst>
        </pc:picChg>
        <pc:picChg chg="mod topLvl">
          <ac:chgData name="Sara Weis" userId="6a51f4e6-0e93-4a18-834c-a49e1ed77407" providerId="ADAL" clId="{6959E033-7E6A-4EA0-AB19-75F676599088}" dt="2025-01-02T17:00:26.168" v="180" actId="164"/>
          <ac:picMkLst>
            <pc:docMk/>
            <pc:sldMk cId="1407140874" sldId="309"/>
            <ac:picMk id="21" creationId="{FD23F2EB-CD30-4B78-8347-E59C22718A82}"/>
          </ac:picMkLst>
        </pc:picChg>
        <pc:picChg chg="mod topLvl">
          <ac:chgData name="Sara Weis" userId="6a51f4e6-0e93-4a18-834c-a49e1ed77407" providerId="ADAL" clId="{6959E033-7E6A-4EA0-AB19-75F676599088}" dt="2025-01-02T17:00:26.168" v="180" actId="164"/>
          <ac:picMkLst>
            <pc:docMk/>
            <pc:sldMk cId="1407140874" sldId="309"/>
            <ac:picMk id="45" creationId="{E5BF901F-73B1-4866-B87E-A2921145A5D4}"/>
          </ac:picMkLst>
        </pc:picChg>
        <pc:picChg chg="mod topLvl">
          <ac:chgData name="Sara Weis" userId="6a51f4e6-0e93-4a18-834c-a49e1ed77407" providerId="ADAL" clId="{6959E033-7E6A-4EA0-AB19-75F676599088}" dt="2025-01-02T17:00:26.168" v="180" actId="164"/>
          <ac:picMkLst>
            <pc:docMk/>
            <pc:sldMk cId="1407140874" sldId="309"/>
            <ac:picMk id="46" creationId="{D63FE4B1-4A92-4060-97D4-2DCCFD5A0A57}"/>
          </ac:picMkLst>
        </pc:picChg>
        <pc:picChg chg="mod topLvl">
          <ac:chgData name="Sara Weis" userId="6a51f4e6-0e93-4a18-834c-a49e1ed77407" providerId="ADAL" clId="{6959E033-7E6A-4EA0-AB19-75F676599088}" dt="2025-01-02T17:00:26.168" v="180" actId="164"/>
          <ac:picMkLst>
            <pc:docMk/>
            <pc:sldMk cId="1407140874" sldId="309"/>
            <ac:picMk id="47" creationId="{CC3F405E-00F9-49AE-834F-8D02BC0DEDDB}"/>
          </ac:picMkLst>
        </pc:picChg>
        <pc:picChg chg="mod topLvl">
          <ac:chgData name="Sara Weis" userId="6a51f4e6-0e93-4a18-834c-a49e1ed77407" providerId="ADAL" clId="{6959E033-7E6A-4EA0-AB19-75F676599088}" dt="2025-01-02T17:00:26.168" v="180" actId="164"/>
          <ac:picMkLst>
            <pc:docMk/>
            <pc:sldMk cId="1407140874" sldId="309"/>
            <ac:picMk id="49" creationId="{D6E85C12-BFDD-4BEA-AEA9-8FB8BDDFA099}"/>
          </ac:picMkLst>
        </pc:picChg>
        <pc:picChg chg="mod topLvl">
          <ac:chgData name="Sara Weis" userId="6a51f4e6-0e93-4a18-834c-a49e1ed77407" providerId="ADAL" clId="{6959E033-7E6A-4EA0-AB19-75F676599088}" dt="2025-01-02T17:00:26.168" v="180" actId="164"/>
          <ac:picMkLst>
            <pc:docMk/>
            <pc:sldMk cId="1407140874" sldId="309"/>
            <ac:picMk id="54" creationId="{96DAD91F-5FD9-4B38-8EA7-D2D986C34E88}"/>
          </ac:picMkLst>
        </pc:picChg>
        <pc:picChg chg="mod topLvl">
          <ac:chgData name="Sara Weis" userId="6a51f4e6-0e93-4a18-834c-a49e1ed77407" providerId="ADAL" clId="{6959E033-7E6A-4EA0-AB19-75F676599088}" dt="2025-01-02T17:00:26.168" v="180" actId="164"/>
          <ac:picMkLst>
            <pc:docMk/>
            <pc:sldMk cId="1407140874" sldId="309"/>
            <ac:picMk id="58" creationId="{3AD79D2C-BE67-4737-BD89-A0AB15F9DDF5}"/>
          </ac:picMkLst>
        </pc:picChg>
        <pc:cxnChg chg="mod topLvl">
          <ac:chgData name="Sara Weis" userId="6a51f4e6-0e93-4a18-834c-a49e1ed77407" providerId="ADAL" clId="{6959E033-7E6A-4EA0-AB19-75F676599088}" dt="2025-01-02T17:00:26.168" v="180" actId="164"/>
          <ac:cxnSpMkLst>
            <pc:docMk/>
            <pc:sldMk cId="1407140874" sldId="309"/>
            <ac:cxnSpMk id="61" creationId="{60770B83-1127-4F2D-B417-7730032C6158}"/>
          </ac:cxnSpMkLst>
        </pc:cxnChg>
        <pc:cxnChg chg="mod topLvl">
          <ac:chgData name="Sara Weis" userId="6a51f4e6-0e93-4a18-834c-a49e1ed77407" providerId="ADAL" clId="{6959E033-7E6A-4EA0-AB19-75F676599088}" dt="2025-01-02T17:00:26.168" v="180" actId="164"/>
          <ac:cxnSpMkLst>
            <pc:docMk/>
            <pc:sldMk cId="1407140874" sldId="309"/>
            <ac:cxnSpMk id="65" creationId="{36869760-8BC8-400F-9233-EDB338402EF1}"/>
          </ac:cxnSpMkLst>
        </pc:cxnChg>
        <pc:cxnChg chg="mod topLvl">
          <ac:chgData name="Sara Weis" userId="6a51f4e6-0e93-4a18-834c-a49e1ed77407" providerId="ADAL" clId="{6959E033-7E6A-4EA0-AB19-75F676599088}" dt="2025-01-02T17:00:26.168" v="180" actId="164"/>
          <ac:cxnSpMkLst>
            <pc:docMk/>
            <pc:sldMk cId="1407140874" sldId="309"/>
            <ac:cxnSpMk id="68" creationId="{8162CB15-C774-43CB-8E29-6C531374815F}"/>
          </ac:cxnSpMkLst>
        </pc:cxnChg>
      </pc:sldChg>
      <pc:sldChg chg="addSp delSp modSp">
        <pc:chgData name="Sara Weis" userId="6a51f4e6-0e93-4a18-834c-a49e1ed77407" providerId="ADAL" clId="{6959E033-7E6A-4EA0-AB19-75F676599088}" dt="2025-01-02T17:16:52.628" v="391" actId="1076"/>
        <pc:sldMkLst>
          <pc:docMk/>
          <pc:sldMk cId="2712744224" sldId="311"/>
        </pc:sldMkLst>
        <pc:spChg chg="add mod">
          <ac:chgData name="Sara Weis" userId="6a51f4e6-0e93-4a18-834c-a49e1ed77407" providerId="ADAL" clId="{6959E033-7E6A-4EA0-AB19-75F676599088}" dt="2025-01-02T17:16:49.358" v="390" actId="403"/>
          <ac:spMkLst>
            <pc:docMk/>
            <pc:sldMk cId="2712744224" sldId="311"/>
            <ac:spMk id="2" creationId="{8FEA17E4-D707-40D4-B8A6-05A0F86B4ED8}"/>
          </ac:spMkLst>
        </pc:spChg>
        <pc:spChg chg="del">
          <ac:chgData name="Sara Weis" userId="6a51f4e6-0e93-4a18-834c-a49e1ed77407" providerId="ADAL" clId="{6959E033-7E6A-4EA0-AB19-75F676599088}" dt="2025-01-02T17:04:36.070" v="335" actId="478"/>
          <ac:spMkLst>
            <pc:docMk/>
            <pc:sldMk cId="2712744224" sldId="311"/>
            <ac:spMk id="4" creationId="{EFF1A090-F7E6-4492-A0E2-DB77C11864EC}"/>
          </ac:spMkLst>
        </pc:spChg>
        <pc:spChg chg="del">
          <ac:chgData name="Sara Weis" userId="6a51f4e6-0e93-4a18-834c-a49e1ed77407" providerId="ADAL" clId="{6959E033-7E6A-4EA0-AB19-75F676599088}" dt="2025-01-02T17:04:05.317" v="293" actId="478"/>
          <ac:spMkLst>
            <pc:docMk/>
            <pc:sldMk cId="2712744224" sldId="311"/>
            <ac:spMk id="8" creationId="{176DA74B-212B-4CD8-AD83-20D4227BE0BE}"/>
          </ac:spMkLst>
        </pc:spChg>
        <pc:spChg chg="add del mod">
          <ac:chgData name="Sara Weis" userId="6a51f4e6-0e93-4a18-834c-a49e1ed77407" providerId="ADAL" clId="{6959E033-7E6A-4EA0-AB19-75F676599088}" dt="2025-01-02T17:04:53.166" v="342" actId="478"/>
          <ac:spMkLst>
            <pc:docMk/>
            <pc:sldMk cId="2712744224" sldId="311"/>
            <ac:spMk id="31" creationId="{C56981B2-F415-4A9E-A873-F7DE5E9788A4}"/>
          </ac:spMkLst>
        </pc:spChg>
        <pc:grpChg chg="del">
          <ac:chgData name="Sara Weis" userId="6a51f4e6-0e93-4a18-834c-a49e1ed77407" providerId="ADAL" clId="{6959E033-7E6A-4EA0-AB19-75F676599088}" dt="2025-01-02T17:04:05.317" v="293" actId="478"/>
          <ac:grpSpMkLst>
            <pc:docMk/>
            <pc:sldMk cId="2712744224" sldId="311"/>
            <ac:grpSpMk id="17" creationId="{3AD46ADA-27C5-4509-BC5D-8E2838B8B03B}"/>
          </ac:grpSpMkLst>
        </pc:grpChg>
        <pc:grpChg chg="del">
          <ac:chgData name="Sara Weis" userId="6a51f4e6-0e93-4a18-834c-a49e1ed77407" providerId="ADAL" clId="{6959E033-7E6A-4EA0-AB19-75F676599088}" dt="2025-01-02T17:04:05.317" v="293" actId="478"/>
          <ac:grpSpMkLst>
            <pc:docMk/>
            <pc:sldMk cId="2712744224" sldId="311"/>
            <ac:grpSpMk id="32" creationId="{AEFCE027-3D20-461D-B064-12E9E1F01B51}"/>
          </ac:grpSpMkLst>
        </pc:grpChg>
        <pc:graphicFrameChg chg="del">
          <ac:chgData name="Sara Weis" userId="6a51f4e6-0e93-4a18-834c-a49e1ed77407" providerId="ADAL" clId="{6959E033-7E6A-4EA0-AB19-75F676599088}" dt="2025-01-02T17:04:05.317" v="293" actId="478"/>
          <ac:graphicFrameMkLst>
            <pc:docMk/>
            <pc:sldMk cId="2712744224" sldId="311"/>
            <ac:graphicFrameMk id="66" creationId="{111A6526-7355-44C6-8032-64EE94B50FD5}"/>
          </ac:graphicFrameMkLst>
        </pc:graphicFrameChg>
        <pc:picChg chg="mod">
          <ac:chgData name="Sara Weis" userId="6a51f4e6-0e93-4a18-834c-a49e1ed77407" providerId="ADAL" clId="{6959E033-7E6A-4EA0-AB19-75F676599088}" dt="2025-01-02T17:16:52.628" v="391" actId="1076"/>
          <ac:picMkLst>
            <pc:docMk/>
            <pc:sldMk cId="2712744224" sldId="311"/>
            <ac:picMk id="7" creationId="{1351158B-83E9-448C-978B-1EA485DEA316}"/>
          </ac:picMkLst>
        </pc:picChg>
        <pc:cxnChg chg="del">
          <ac:chgData name="Sara Weis" userId="6a51f4e6-0e93-4a18-834c-a49e1ed77407" providerId="ADAL" clId="{6959E033-7E6A-4EA0-AB19-75F676599088}" dt="2025-01-02T17:04:05.317" v="293" actId="478"/>
          <ac:cxnSpMkLst>
            <pc:docMk/>
            <pc:sldMk cId="2712744224" sldId="311"/>
            <ac:cxnSpMk id="67" creationId="{900452E5-2F38-400C-871D-592F39BB8149}"/>
          </ac:cxnSpMkLst>
        </pc:cxnChg>
      </pc:sldChg>
      <pc:sldChg chg="addSp delSp modSp add">
        <pc:chgData name="Sara Weis" userId="6a51f4e6-0e93-4a18-834c-a49e1ed77407" providerId="ADAL" clId="{6959E033-7E6A-4EA0-AB19-75F676599088}" dt="2025-01-02T17:17:59.407" v="418" actId="20577"/>
        <pc:sldMkLst>
          <pc:docMk/>
          <pc:sldMk cId="2356307124" sldId="312"/>
        </pc:sldMkLst>
        <pc:spChg chg="add mod">
          <ac:chgData name="Sara Weis" userId="6a51f4e6-0e93-4a18-834c-a49e1ed77407" providerId="ADAL" clId="{6959E033-7E6A-4EA0-AB19-75F676599088}" dt="2025-01-02T17:17:59.407" v="418" actId="20577"/>
          <ac:spMkLst>
            <pc:docMk/>
            <pc:sldMk cId="2356307124" sldId="312"/>
            <ac:spMk id="2" creationId="{4D9D5902-05D5-4827-AE64-44E64AA62EA2}"/>
          </ac:spMkLst>
        </pc:spChg>
        <pc:spChg chg="del">
          <ac:chgData name="Sara Weis" userId="6a51f4e6-0e93-4a18-834c-a49e1ed77407" providerId="ADAL" clId="{6959E033-7E6A-4EA0-AB19-75F676599088}" dt="2025-01-02T17:02:44.579" v="235" actId="478"/>
          <ac:spMkLst>
            <pc:docMk/>
            <pc:sldMk cId="2356307124" sldId="312"/>
            <ac:spMk id="4" creationId="{EFF1A090-F7E6-4492-A0E2-DB77C11864EC}"/>
          </ac:spMkLst>
        </pc:spChg>
        <pc:spChg chg="del">
          <ac:chgData name="Sara Weis" userId="6a51f4e6-0e93-4a18-834c-a49e1ed77407" providerId="ADAL" clId="{6959E033-7E6A-4EA0-AB19-75F676599088}" dt="2025-01-02T17:02:49.963" v="238" actId="478"/>
          <ac:spMkLst>
            <pc:docMk/>
            <pc:sldMk cId="2356307124" sldId="312"/>
            <ac:spMk id="8" creationId="{176DA74B-212B-4CD8-AD83-20D4227BE0BE}"/>
          </ac:spMkLst>
        </pc:spChg>
        <pc:spChg chg="del mod">
          <ac:chgData name="Sara Weis" userId="6a51f4e6-0e93-4a18-834c-a49e1ed77407" providerId="ADAL" clId="{6959E033-7E6A-4EA0-AB19-75F676599088}" dt="2025-01-02T17:04:58.125" v="343" actId="478"/>
          <ac:spMkLst>
            <pc:docMk/>
            <pc:sldMk cId="2356307124" sldId="312"/>
            <ac:spMk id="31" creationId="{C56981B2-F415-4A9E-A873-F7DE5E9788A4}"/>
          </ac:spMkLst>
        </pc:spChg>
        <pc:spChg chg="mod">
          <ac:chgData name="Sara Weis" userId="6a51f4e6-0e93-4a18-834c-a49e1ed77407" providerId="ADAL" clId="{6959E033-7E6A-4EA0-AB19-75F676599088}" dt="2025-01-02T17:17:16.576" v="404" actId="404"/>
          <ac:spMkLst>
            <pc:docMk/>
            <pc:sldMk cId="2356307124" sldId="312"/>
            <ac:spMk id="34" creationId="{7245DFBF-E367-42CE-9BC0-1CC284935543}"/>
          </ac:spMkLst>
        </pc:spChg>
        <pc:spChg chg="mod">
          <ac:chgData name="Sara Weis" userId="6a51f4e6-0e93-4a18-834c-a49e1ed77407" providerId="ADAL" clId="{6959E033-7E6A-4EA0-AB19-75F676599088}" dt="2025-01-02T17:17:20.827" v="405" actId="1076"/>
          <ac:spMkLst>
            <pc:docMk/>
            <pc:sldMk cId="2356307124" sldId="312"/>
            <ac:spMk id="35" creationId="{FF84D828-1683-4212-9A04-530622F68783}"/>
          </ac:spMkLst>
        </pc:spChg>
        <pc:spChg chg="mod">
          <ac:chgData name="Sara Weis" userId="6a51f4e6-0e93-4a18-834c-a49e1ed77407" providerId="ADAL" clId="{6959E033-7E6A-4EA0-AB19-75F676599088}" dt="2025-01-02T17:17:24.806" v="407" actId="14100"/>
          <ac:spMkLst>
            <pc:docMk/>
            <pc:sldMk cId="2356307124" sldId="312"/>
            <ac:spMk id="36" creationId="{1FC9477D-6E24-442C-9FA5-58E70ABD35D1}"/>
          </ac:spMkLst>
        </pc:spChg>
        <pc:spChg chg="mod">
          <ac:chgData name="Sara Weis" userId="6a51f4e6-0e93-4a18-834c-a49e1ed77407" providerId="ADAL" clId="{6959E033-7E6A-4EA0-AB19-75F676599088}" dt="2025-01-02T17:17:27.382" v="408" actId="1076"/>
          <ac:spMkLst>
            <pc:docMk/>
            <pc:sldMk cId="2356307124" sldId="312"/>
            <ac:spMk id="37" creationId="{77012511-9E81-45CF-B84C-A520A6C63417}"/>
          </ac:spMkLst>
        </pc:spChg>
        <pc:spChg chg="mod">
          <ac:chgData name="Sara Weis" userId="6a51f4e6-0e93-4a18-834c-a49e1ed77407" providerId="ADAL" clId="{6959E033-7E6A-4EA0-AB19-75F676599088}" dt="2025-01-02T17:17:16.576" v="404" actId="404"/>
          <ac:spMkLst>
            <pc:docMk/>
            <pc:sldMk cId="2356307124" sldId="312"/>
            <ac:spMk id="38" creationId="{3DB68739-9E51-4261-B67F-EEB63C4BA948}"/>
          </ac:spMkLst>
        </pc:spChg>
        <pc:spChg chg="mod">
          <ac:chgData name="Sara Weis" userId="6a51f4e6-0e93-4a18-834c-a49e1ed77407" providerId="ADAL" clId="{6959E033-7E6A-4EA0-AB19-75F676599088}" dt="2025-01-02T17:17:16.576" v="404" actId="404"/>
          <ac:spMkLst>
            <pc:docMk/>
            <pc:sldMk cId="2356307124" sldId="312"/>
            <ac:spMk id="39" creationId="{B5400EC5-E183-4B29-A883-E4711603516E}"/>
          </ac:spMkLst>
        </pc:spChg>
        <pc:grpChg chg="add del mod">
          <ac:chgData name="Sara Weis" userId="6a51f4e6-0e93-4a18-834c-a49e1ed77407" providerId="ADAL" clId="{6959E033-7E6A-4EA0-AB19-75F676599088}" dt="2025-01-02T17:17:10.519" v="396" actId="165"/>
          <ac:grpSpMkLst>
            <pc:docMk/>
            <pc:sldMk cId="2356307124" sldId="312"/>
            <ac:grpSpMk id="5" creationId="{F0736E05-44C9-4E0F-B450-06399BD2E38F}"/>
          </ac:grpSpMkLst>
        </pc:grpChg>
        <pc:grpChg chg="mod topLvl">
          <ac:chgData name="Sara Weis" userId="6a51f4e6-0e93-4a18-834c-a49e1ed77407" providerId="ADAL" clId="{6959E033-7E6A-4EA0-AB19-75F676599088}" dt="2025-01-02T17:17:52.766" v="415" actId="1076"/>
          <ac:grpSpMkLst>
            <pc:docMk/>
            <pc:sldMk cId="2356307124" sldId="312"/>
            <ac:grpSpMk id="17" creationId="{3AD46ADA-27C5-4509-BC5D-8E2838B8B03B}"/>
          </ac:grpSpMkLst>
        </pc:grpChg>
        <pc:grpChg chg="mod topLvl">
          <ac:chgData name="Sara Weis" userId="6a51f4e6-0e93-4a18-834c-a49e1ed77407" providerId="ADAL" clId="{6959E033-7E6A-4EA0-AB19-75F676599088}" dt="2025-01-02T17:17:52.766" v="415" actId="1076"/>
          <ac:grpSpMkLst>
            <pc:docMk/>
            <pc:sldMk cId="2356307124" sldId="312"/>
            <ac:grpSpMk id="32" creationId="{AEFCE027-3D20-461D-B064-12E9E1F01B51}"/>
          </ac:grpSpMkLst>
        </pc:grpChg>
        <pc:grpChg chg="mod">
          <ac:chgData name="Sara Weis" userId="6a51f4e6-0e93-4a18-834c-a49e1ed77407" providerId="ADAL" clId="{6959E033-7E6A-4EA0-AB19-75F676599088}" dt="2025-01-02T17:17:52.766" v="415" actId="1076"/>
          <ac:grpSpMkLst>
            <pc:docMk/>
            <pc:sldMk cId="2356307124" sldId="312"/>
            <ac:grpSpMk id="33" creationId="{2ED8BAA9-40D7-40CC-906F-F42E40F72D84}"/>
          </ac:grpSpMkLst>
        </pc:grpChg>
        <pc:graphicFrameChg chg="mod topLvl">
          <ac:chgData name="Sara Weis" userId="6a51f4e6-0e93-4a18-834c-a49e1ed77407" providerId="ADAL" clId="{6959E033-7E6A-4EA0-AB19-75F676599088}" dt="2025-01-02T17:17:52.766" v="415" actId="1076"/>
          <ac:graphicFrameMkLst>
            <pc:docMk/>
            <pc:sldMk cId="2356307124" sldId="312"/>
            <ac:graphicFrameMk id="66" creationId="{111A6526-7355-44C6-8032-64EE94B50FD5}"/>
          </ac:graphicFrameMkLst>
        </pc:graphicFrameChg>
        <pc:picChg chg="mod">
          <ac:chgData name="Sara Weis" userId="6a51f4e6-0e93-4a18-834c-a49e1ed77407" providerId="ADAL" clId="{6959E033-7E6A-4EA0-AB19-75F676599088}" dt="2025-01-02T17:05:17.936" v="349" actId="1076"/>
          <ac:picMkLst>
            <pc:docMk/>
            <pc:sldMk cId="2356307124" sldId="312"/>
            <ac:picMk id="3" creationId="{A6327666-5840-B3BB-17A2-7B4D54247304}"/>
          </ac:picMkLst>
        </pc:picChg>
        <pc:picChg chg="del">
          <ac:chgData name="Sara Weis" userId="6a51f4e6-0e93-4a18-834c-a49e1ed77407" providerId="ADAL" clId="{6959E033-7E6A-4EA0-AB19-75F676599088}" dt="2025-01-02T17:02:44.579" v="235" actId="478"/>
          <ac:picMkLst>
            <pc:docMk/>
            <pc:sldMk cId="2356307124" sldId="312"/>
            <ac:picMk id="7" creationId="{1351158B-83E9-448C-978B-1EA485DEA316}"/>
          </ac:picMkLst>
        </pc:picChg>
        <pc:cxnChg chg="mod topLvl">
          <ac:chgData name="Sara Weis" userId="6a51f4e6-0e93-4a18-834c-a49e1ed77407" providerId="ADAL" clId="{6959E033-7E6A-4EA0-AB19-75F676599088}" dt="2025-01-02T17:17:52.766" v="415" actId="1076"/>
          <ac:cxnSpMkLst>
            <pc:docMk/>
            <pc:sldMk cId="2356307124" sldId="312"/>
            <ac:cxnSpMk id="67" creationId="{900452E5-2F38-400C-871D-592F39BB8149}"/>
          </ac:cxnSpMkLst>
        </pc:cxnChg>
      </pc:sldChg>
    </pc:docChg>
  </pc:docChgLst>
  <pc:docChgLst>
    <pc:chgData name="Sara Weis" userId="6a51f4e6-0e93-4a18-834c-a49e1ed77407" providerId="ADAL" clId="{5B9D748F-4140-4F29-A6FB-884F3F5921E6}"/>
    <pc:docChg chg="delSld modSld">
      <pc:chgData name="Sara Weis" userId="6a51f4e6-0e93-4a18-834c-a49e1ed77407" providerId="ADAL" clId="{5B9D748F-4140-4F29-A6FB-884F3F5921E6}" dt="2025-01-02T16:47:04.763" v="12" actId="20577"/>
      <pc:docMkLst>
        <pc:docMk/>
      </pc:docMkLst>
      <pc:sldChg chg="modSp">
        <pc:chgData name="Sara Weis" userId="6a51f4e6-0e93-4a18-834c-a49e1ed77407" providerId="ADAL" clId="{5B9D748F-4140-4F29-A6FB-884F3F5921E6}" dt="2025-01-02T16:46:55.225" v="6" actId="20577"/>
        <pc:sldMkLst>
          <pc:docMk/>
          <pc:sldMk cId="2106248321" sldId="298"/>
        </pc:sldMkLst>
        <pc:spChg chg="mod">
          <ac:chgData name="Sara Weis" userId="6a51f4e6-0e93-4a18-834c-a49e1ed77407" providerId="ADAL" clId="{5B9D748F-4140-4F29-A6FB-884F3F5921E6}" dt="2025-01-02T16:46:52.776" v="4" actId="20577"/>
          <ac:spMkLst>
            <pc:docMk/>
            <pc:sldMk cId="2106248321" sldId="298"/>
            <ac:spMk id="23" creationId="{9837469B-6902-495A-86E3-722D7C6A57DC}"/>
          </ac:spMkLst>
        </pc:spChg>
        <pc:spChg chg="mod">
          <ac:chgData name="Sara Weis" userId="6a51f4e6-0e93-4a18-834c-a49e1ed77407" providerId="ADAL" clId="{5B9D748F-4140-4F29-A6FB-884F3F5921E6}" dt="2025-01-02T16:46:48.408" v="2" actId="20577"/>
          <ac:spMkLst>
            <pc:docMk/>
            <pc:sldMk cId="2106248321" sldId="298"/>
            <ac:spMk id="45" creationId="{F3A9156C-C54C-4614-ABB9-5AF095F0F775}"/>
          </ac:spMkLst>
        </pc:spChg>
        <pc:spChg chg="mod">
          <ac:chgData name="Sara Weis" userId="6a51f4e6-0e93-4a18-834c-a49e1ed77407" providerId="ADAL" clId="{5B9D748F-4140-4F29-A6FB-884F3F5921E6}" dt="2025-01-02T16:46:55.225" v="6" actId="20577"/>
          <ac:spMkLst>
            <pc:docMk/>
            <pc:sldMk cId="2106248321" sldId="298"/>
            <ac:spMk id="70" creationId="{7A30D47F-4FE9-4840-9977-6022DD4A371A}"/>
          </ac:spMkLst>
        </pc:spChg>
      </pc:sldChg>
      <pc:sldChg chg="del">
        <pc:chgData name="Sara Weis" userId="6a51f4e6-0e93-4a18-834c-a49e1ed77407" providerId="ADAL" clId="{5B9D748F-4140-4F29-A6FB-884F3F5921E6}" dt="2025-01-02T16:46:43.245" v="0" actId="2696"/>
        <pc:sldMkLst>
          <pc:docMk/>
          <pc:sldMk cId="3697787146" sldId="301"/>
        </pc:sldMkLst>
      </pc:sldChg>
      <pc:sldChg chg="modSp">
        <pc:chgData name="Sara Weis" userId="6a51f4e6-0e93-4a18-834c-a49e1ed77407" providerId="ADAL" clId="{5B9D748F-4140-4F29-A6FB-884F3F5921E6}" dt="2025-01-02T16:46:58.680" v="8" actId="20577"/>
        <pc:sldMkLst>
          <pc:docMk/>
          <pc:sldMk cId="1407140874" sldId="309"/>
        </pc:sldMkLst>
        <pc:spChg chg="mod">
          <ac:chgData name="Sara Weis" userId="6a51f4e6-0e93-4a18-834c-a49e1ed77407" providerId="ADAL" clId="{5B9D748F-4140-4F29-A6FB-884F3F5921E6}" dt="2025-01-02T16:46:58.680" v="8" actId="20577"/>
          <ac:spMkLst>
            <pc:docMk/>
            <pc:sldMk cId="1407140874" sldId="309"/>
            <ac:spMk id="5" creationId="{B847A6B5-FE3F-456F-A592-96E2D8DDCCD8}"/>
          </ac:spMkLst>
        </pc:spChg>
      </pc:sldChg>
      <pc:sldChg chg="modSp">
        <pc:chgData name="Sara Weis" userId="6a51f4e6-0e93-4a18-834c-a49e1ed77407" providerId="ADAL" clId="{5B9D748F-4140-4F29-A6FB-884F3F5921E6}" dt="2025-01-02T16:47:04.763" v="12" actId="20577"/>
        <pc:sldMkLst>
          <pc:docMk/>
          <pc:sldMk cId="2712744224" sldId="311"/>
        </pc:sldMkLst>
        <pc:spChg chg="mod">
          <ac:chgData name="Sara Weis" userId="6a51f4e6-0e93-4a18-834c-a49e1ed77407" providerId="ADAL" clId="{5B9D748F-4140-4F29-A6FB-884F3F5921E6}" dt="2025-01-02T16:47:02.568" v="10" actId="20577"/>
          <ac:spMkLst>
            <pc:docMk/>
            <pc:sldMk cId="2712744224" sldId="311"/>
            <ac:spMk id="4" creationId="{EFF1A090-F7E6-4492-A0E2-DB77C11864EC}"/>
          </ac:spMkLst>
        </pc:spChg>
        <pc:spChg chg="mod">
          <ac:chgData name="Sara Weis" userId="6a51f4e6-0e93-4a18-834c-a49e1ed77407" providerId="ADAL" clId="{5B9D748F-4140-4F29-A6FB-884F3F5921E6}" dt="2025-01-02T16:47:04.763" v="12" actId="20577"/>
          <ac:spMkLst>
            <pc:docMk/>
            <pc:sldMk cId="2712744224" sldId="311"/>
            <ac:spMk id="8" creationId="{176DA74B-212B-4CD8-AD83-20D4227BE0BE}"/>
          </ac:spMkLst>
        </pc:spChg>
      </pc:sldChg>
    </pc:docChg>
  </pc:docChgLst>
  <pc:docChgLst>
    <pc:chgData name="Sara Weis" userId="6a51f4e6-0e93-4a18-834c-a49e1ed77407" providerId="ADAL" clId="{0C59D3F2-CB2A-4ED1-9C90-A46B5682BA8A}"/>
    <pc:docChg chg="delSld">
      <pc:chgData name="Sara Weis" userId="6a51f4e6-0e93-4a18-834c-a49e1ed77407" providerId="ADAL" clId="{0C59D3F2-CB2A-4ED1-9C90-A46B5682BA8A}" dt="2025-01-02T17:23:07.986" v="2" actId="2696"/>
      <pc:docMkLst>
        <pc:docMk/>
      </pc:docMkLst>
      <pc:sldChg chg="del">
        <pc:chgData name="Sara Weis" userId="6a51f4e6-0e93-4a18-834c-a49e1ed77407" providerId="ADAL" clId="{0C59D3F2-CB2A-4ED1-9C90-A46B5682BA8A}" dt="2025-01-02T17:23:06.361" v="1" actId="2696"/>
        <pc:sldMkLst>
          <pc:docMk/>
          <pc:sldMk cId="2106248321" sldId="298"/>
        </pc:sldMkLst>
      </pc:sldChg>
      <pc:sldChg chg="del">
        <pc:chgData name="Sara Weis" userId="6a51f4e6-0e93-4a18-834c-a49e1ed77407" providerId="ADAL" clId="{0C59D3F2-CB2A-4ED1-9C90-A46B5682BA8A}" dt="2025-01-02T17:23:06.359" v="0" actId="2696"/>
        <pc:sldMkLst>
          <pc:docMk/>
          <pc:sldMk cId="1407140874" sldId="309"/>
        </pc:sldMkLst>
      </pc:sldChg>
      <pc:sldChg chg="del">
        <pc:chgData name="Sara Weis" userId="6a51f4e6-0e93-4a18-834c-a49e1ed77407" providerId="ADAL" clId="{0C59D3F2-CB2A-4ED1-9C90-A46B5682BA8A}" dt="2025-01-02T17:23:07.986" v="2" actId="2696"/>
        <pc:sldMkLst>
          <pc:docMk/>
          <pc:sldMk cId="2356307124" sldId="312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587" y="0"/>
            <a:ext cx="3169920" cy="481727"/>
          </a:xfrm>
          <a:prstGeom prst="rect">
            <a:avLst/>
          </a:prstGeom>
        </p:spPr>
        <p:txBody>
          <a:bodyPr vert="horz" lIns="96661" tIns="48331" rIns="96661" bIns="48331" rtlCol="0"/>
          <a:lstStyle>
            <a:lvl1pPr algn="r">
              <a:defRPr sz="1300"/>
            </a:lvl1pPr>
          </a:lstStyle>
          <a:p>
            <a:fld id="{8556F641-4CF0-450A-AF50-26BA00F47CDE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35238" y="1200150"/>
            <a:ext cx="2244725" cy="324008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61" tIns="48331" rIns="96661" bIns="48331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520" y="4620577"/>
            <a:ext cx="5852160" cy="3780473"/>
          </a:xfrm>
          <a:prstGeom prst="rect">
            <a:avLst/>
          </a:prstGeom>
        </p:spPr>
        <p:txBody>
          <a:bodyPr vert="horz" lIns="96661" tIns="48331" rIns="96661" bIns="48331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l">
              <a:defRPr sz="13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587" y="9119474"/>
            <a:ext cx="3169920" cy="481726"/>
          </a:xfrm>
          <a:prstGeom prst="rect">
            <a:avLst/>
          </a:prstGeom>
        </p:spPr>
        <p:txBody>
          <a:bodyPr vert="horz" lIns="96661" tIns="48331" rIns="96661" bIns="48331" rtlCol="0" anchor="b"/>
          <a:lstStyle>
            <a:lvl1pPr algn="r">
              <a:defRPr sz="1300"/>
            </a:lvl1pPr>
          </a:lstStyle>
          <a:p>
            <a:fld id="{306F44C2-743C-4165-B45D-193A312A7D2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572851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306F44C2-743C-4165-B45D-193A312A7D28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3936380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325044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877690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93299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22919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35701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59066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1573106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7151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9967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903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68218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1B7451F-75FE-468E-B432-185B2D62D082}" type="datetimeFigureOut">
              <a:rPr lang="en-US" smtClean="0"/>
              <a:t>1/2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4D54D952-7280-4B8F-A320-F189AA1209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792040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>
            <a:extLst>
              <a:ext uri="{FF2B5EF4-FFF2-40B4-BE49-F238E27FC236}">
                <a16:creationId xmlns:a16="http://schemas.microsoft.com/office/drawing/2014/main" id="{1351158B-83E9-448C-978B-1EA485DEA31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8019" y="1145881"/>
            <a:ext cx="3187961" cy="2662347"/>
          </a:xfrm>
          <a:prstGeom prst="rect">
            <a:avLst/>
          </a:prstGeom>
        </p:spPr>
      </p:pic>
      <p:pic>
        <p:nvPicPr>
          <p:cNvPr id="3" name="Picture 2" descr="A close up of a colorful pattern&#10;&#10;Description automatically generated">
            <a:extLst>
              <a:ext uri="{FF2B5EF4-FFF2-40B4-BE49-F238E27FC236}">
                <a16:creationId xmlns:a16="http://schemas.microsoft.com/office/drawing/2014/main" id="{A6327666-5840-B3BB-17A2-7B4D5424730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0318797" y="10367778"/>
            <a:ext cx="2743200" cy="2743200"/>
          </a:xfrm>
          <a:prstGeom prst="rect">
            <a:avLst/>
          </a:prstGeom>
        </p:spPr>
      </p:pic>
      <p:sp>
        <p:nvSpPr>
          <p:cNvPr id="2" name="Rectangle 1">
            <a:extLst>
              <a:ext uri="{FF2B5EF4-FFF2-40B4-BE49-F238E27FC236}">
                <a16:creationId xmlns:a16="http://schemas.microsoft.com/office/drawing/2014/main" id="{8FEA17E4-D707-40D4-B8A6-05A0F86B4ED8}"/>
              </a:ext>
            </a:extLst>
          </p:cNvPr>
          <p:cNvSpPr/>
          <p:nvPr/>
        </p:nvSpPr>
        <p:spPr>
          <a:xfrm>
            <a:off x="306315" y="103031"/>
            <a:ext cx="6310645" cy="104285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100" b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ry Figure S5:  BsAb treatment does not impact CAF mRNA expression of ECM proteins</a:t>
            </a:r>
            <a:endParaRPr lang="en-US" sz="1100" b="1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>
              <a:lnSpc>
                <a:spcPct val="107000"/>
              </a:lnSpc>
              <a:spcAft>
                <a:spcPts val="800"/>
              </a:spcAft>
            </a:pP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AF-1299 and CAF-1424 were incubated with control IgG vs. BsAb for 72 hours, and then processed for qPCR to examine mRNA expression for </a:t>
            </a:r>
            <a:r>
              <a:rPr lang="en-US" sz="10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N1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and </a:t>
            </a:r>
            <a:r>
              <a:rPr lang="en-US" sz="1000" i="1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OL1A1</a:t>
            </a:r>
            <a:r>
              <a:rPr lang="en-US" sz="1000" dirty="0">
                <a:latin typeface="Arial" panose="020B060402020202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 Log2-fold change for BsAb relative to isotype control was calculated for 3 independent experiments.</a:t>
            </a:r>
            <a:endParaRPr lang="en-US" sz="10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127442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lcf76f155ced4ddcb4097134ff3c332f xmlns="2543e7ec-7072-4b75-829f-0ed03e19ff1e">
      <Terms xmlns="http://schemas.microsoft.com/office/infopath/2007/PartnerControls"/>
    </lcf76f155ced4ddcb4097134ff3c332f>
    <TaxCatchAll xmlns="57a0c4cc-3c09-49e8-920e-d8be8823b2ff" xsi:nil="true"/>
  </documentManagement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A2F3B51C6BCD074793790340586B5297" ma:contentTypeVersion="18" ma:contentTypeDescription="Create a new document." ma:contentTypeScope="" ma:versionID="d8e7e0b6111b9d67775a07373b940835">
  <xsd:schema xmlns:xsd="http://www.w3.org/2001/XMLSchema" xmlns:xs="http://www.w3.org/2001/XMLSchema" xmlns:p="http://schemas.microsoft.com/office/2006/metadata/properties" xmlns:ns2="57a0c4cc-3c09-49e8-920e-d8be8823b2ff" xmlns:ns3="2543e7ec-7072-4b75-829f-0ed03e19ff1e" targetNamespace="http://schemas.microsoft.com/office/2006/metadata/properties" ma:root="true" ma:fieldsID="26eab72f2527c02910f532a8625ffb45" ns2:_="" ns3:_="">
    <xsd:import namespace="57a0c4cc-3c09-49e8-920e-d8be8823b2ff"/>
    <xsd:import namespace="2543e7ec-7072-4b75-829f-0ed03e19ff1e"/>
    <xsd:element name="properties">
      <xsd:complexType>
        <xsd:sequence>
          <xsd:element name="documentManagement">
            <xsd:complexType>
              <xsd:all>
                <xsd:element ref="ns2:SharedWithUsers" minOccurs="0"/>
                <xsd:element ref="ns2:SharedWithDetails" minOccurs="0"/>
                <xsd:element ref="ns3:MediaServiceMetadata" minOccurs="0"/>
                <xsd:element ref="ns3:MediaServiceFastMetadata" minOccurs="0"/>
                <xsd:element ref="ns3:MediaServiceDateTaken" minOccurs="0"/>
                <xsd:element ref="ns3:MediaServiceAutoTags" minOccurs="0"/>
                <xsd:element ref="ns3:MediaServiceOCR" minOccurs="0"/>
                <xsd:element ref="ns3:MediaServiceGenerationTime" minOccurs="0"/>
                <xsd:element ref="ns3:MediaServiceEventHashCode" minOccurs="0"/>
                <xsd:element ref="ns3:MediaServiceAutoKeyPoints" minOccurs="0"/>
                <xsd:element ref="ns3:MediaServiceKeyPoints" minOccurs="0"/>
                <xsd:element ref="ns3:MediaLengthInSeconds" minOccurs="0"/>
                <xsd:element ref="ns3:MediaServiceLocation" minOccurs="0"/>
                <xsd:element ref="ns3:lcf76f155ced4ddcb4097134ff3c332f" minOccurs="0"/>
                <xsd:element ref="ns2:TaxCatchAll" minOccurs="0"/>
                <xsd:element ref="ns3:MediaServiceObjectDetectorVersions" minOccurs="0"/>
                <xsd:element ref="ns3:MediaServiceSearchProperties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57a0c4cc-3c09-49e8-920e-d8be8823b2ff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Shared With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Shared With Details" ma:internalName="SharedWithDetails" ma:readOnly="true">
      <xsd:simpleType>
        <xsd:restriction base="dms:Note">
          <xsd:maxLength value="255"/>
        </xsd:restriction>
      </xsd:simpleType>
    </xsd:element>
    <xsd:element name="TaxCatchAll" ma:index="23" nillable="true" ma:displayName="Taxonomy Catch All Column" ma:hidden="true" ma:list="{bfe539f8-3b21-43ac-9575-bd53185d5a89}" ma:internalName="TaxCatchAll" ma:showField="CatchAllData" ma:web="57a0c4cc-3c09-49e8-920e-d8be8823b2ff">
      <xsd:complexType>
        <xsd:complexContent>
          <xsd:extension base="dms:MultiChoiceLookup">
            <xsd:sequence>
              <xsd:element name="Value" type="dms:Lookup" maxOccurs="unbounded" minOccurs="0" nillable="true"/>
            </xsd:sequence>
          </xsd:extension>
        </xsd:complexContent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2543e7ec-7072-4b75-829f-0ed03e19ff1e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0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1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DateTaken" ma:index="12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3" nillable="true" ma:displayName="Tags" ma:internalName="MediaServiceAutoTags" ma:readOnly="true">
      <xsd:simpleType>
        <xsd:restriction base="dms:Text"/>
      </xsd:simpleType>
    </xsd:element>
    <xsd:element name="MediaServiceOCR" ma:index="14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5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6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AutoKeyPoints" ma:index="17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8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LengthInSeconds" ma:index="19" nillable="true" ma:displayName="MediaLengthInSeconds" ma:hidden="true" ma:internalName="MediaLengthInSeconds" ma:readOnly="true">
      <xsd:simpleType>
        <xsd:restriction base="dms:Unknown"/>
      </xsd:simpleType>
    </xsd:element>
    <xsd:element name="MediaServiceLocation" ma:index="20" nillable="true" ma:displayName="Location" ma:internalName="MediaServiceLocation" ma:readOnly="true">
      <xsd:simpleType>
        <xsd:restriction base="dms:Text"/>
      </xsd:simpleType>
    </xsd:element>
    <xsd:element name="lcf76f155ced4ddcb4097134ff3c332f" ma:index="22" nillable="true" ma:taxonomy="true" ma:internalName="lcf76f155ced4ddcb4097134ff3c332f" ma:taxonomyFieldName="MediaServiceImageTags" ma:displayName="Image Tags" ma:readOnly="false" ma:fieldId="{5cf76f15-5ced-4ddc-b409-7134ff3c332f}" ma:taxonomyMulti="true" ma:sspId="2ccd466c-82b6-42a3-8ba5-5c7db83406b1" ma:termSetId="09814cd3-568e-fe90-9814-8d621ff8fb84" ma:anchorId="fba54fb3-c3e1-fe81-a776-ca4b69148c4d" ma:open="true" ma:isKeyword="false">
      <xsd:complexType>
        <xsd:sequence>
          <xsd:element ref="pc:Terms" minOccurs="0" maxOccurs="1"/>
        </xsd:sequence>
      </xsd:complexType>
    </xsd:element>
    <xsd:element name="MediaServiceObjectDetectorVersions" ma:index="24" nillable="true" ma:displayName="MediaServiceObjectDetectorVersions" ma:description="" ma:hidden="true" ma:indexed="true" ma:internalName="MediaServiceObjectDetectorVersions" ma:readOnly="true">
      <xsd:simpleType>
        <xsd:restriction base="dms:Text"/>
      </xsd:simpleType>
    </xsd:element>
    <xsd:element name="MediaServiceSearchProperties" ma:index="25" nillable="true" ma:displayName="MediaServiceSearchProperties" ma:hidden="true" ma:internalName="MediaServiceSearchProperties" ma:readOnly="true">
      <xsd:simpleType>
        <xsd:restriction base="dms:Note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428AF018-5240-4F2F-B0A7-10A84DD9D260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08778B21-93DC-4DE6-9C7D-29A88DF3DBC8}">
  <ds:schemaRefs>
    <ds:schemaRef ds:uri="http://schemas.microsoft.com/office/2006/documentManagement/types"/>
    <ds:schemaRef ds:uri="http://purl.org/dc/dcmitype/"/>
    <ds:schemaRef ds:uri="57a0c4cc-3c09-49e8-920e-d8be8823b2ff"/>
    <ds:schemaRef ds:uri="http://purl.org/dc/elements/1.1/"/>
    <ds:schemaRef ds:uri="http://schemas.microsoft.com/office/2006/metadata/properties"/>
    <ds:schemaRef ds:uri="http://schemas.microsoft.com/office/infopath/2007/PartnerControls"/>
    <ds:schemaRef ds:uri="http://purl.org/dc/terms/"/>
    <ds:schemaRef ds:uri="http://schemas.openxmlformats.org/package/2006/metadata/core-properties"/>
    <ds:schemaRef ds:uri="2543e7ec-7072-4b75-829f-0ed03e19ff1e"/>
    <ds:schemaRef ds:uri="http://www.w3.org/XML/1998/namespace"/>
  </ds:schemaRefs>
</ds:datastoreItem>
</file>

<file path=customXml/itemProps3.xml><?xml version="1.0" encoding="utf-8"?>
<ds:datastoreItem xmlns:ds="http://schemas.openxmlformats.org/officeDocument/2006/customXml" ds:itemID="{B01E279D-CEC9-47C5-B8DD-CF8E61B016AF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57a0c4cc-3c09-49e8-920e-d8be8823b2ff"/>
    <ds:schemaRef ds:uri="2543e7ec-7072-4b75-829f-0ed03e19ff1e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51</TotalTime>
  <Words>60</Words>
  <Application>Microsoft Office PowerPoint</Application>
  <PresentationFormat>A4 Paper (210x297 mm)</PresentationFormat>
  <Paragraphs>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u, Chengsheng</dc:creator>
  <cp:lastModifiedBy>Weis, Sara</cp:lastModifiedBy>
  <cp:revision>20</cp:revision>
  <dcterms:created xsi:type="dcterms:W3CDTF">2024-03-19T17:07:22Z</dcterms:created>
  <dcterms:modified xsi:type="dcterms:W3CDTF">2025-01-02T17:23:0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A2F3B51C6BCD074793790340586B5297</vt:lpwstr>
  </property>
  <property fmtid="{D5CDD505-2E9C-101B-9397-08002B2CF9AE}" pid="3" name="MediaServiceImageTags">
    <vt:lpwstr/>
  </property>
</Properties>
</file>